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6119813" cy="8280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713"/>
  </p:normalViewPr>
  <p:slideViewPr>
    <p:cSldViewPr snapToGrid="0" snapToObjects="1">
      <p:cViewPr varScale="1">
        <p:scale>
          <a:sx n="90" d="100"/>
          <a:sy n="90" d="100"/>
        </p:scale>
        <p:origin x="3128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58986" y="1355149"/>
            <a:ext cx="5201841" cy="2882806"/>
          </a:xfrm>
        </p:spPr>
        <p:txBody>
          <a:bodyPr anchor="b"/>
          <a:lstStyle>
            <a:lvl1pPr algn="ctr">
              <a:defRPr sz="4016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64977" y="4349128"/>
            <a:ext cx="4589860" cy="1999179"/>
          </a:xfrm>
        </p:spPr>
        <p:txBody>
          <a:bodyPr/>
          <a:lstStyle>
            <a:lvl1pPr marL="0" indent="0" algn="ctr">
              <a:buNone/>
              <a:defRPr sz="1606"/>
            </a:lvl1pPr>
            <a:lvl2pPr marL="306004" indent="0" algn="ctr">
              <a:buNone/>
              <a:defRPr sz="1339"/>
            </a:lvl2pPr>
            <a:lvl3pPr marL="612008" indent="0" algn="ctr">
              <a:buNone/>
              <a:defRPr sz="1205"/>
            </a:lvl3pPr>
            <a:lvl4pPr marL="918012" indent="0" algn="ctr">
              <a:buNone/>
              <a:defRPr sz="1071"/>
            </a:lvl4pPr>
            <a:lvl5pPr marL="1224016" indent="0" algn="ctr">
              <a:buNone/>
              <a:defRPr sz="1071"/>
            </a:lvl5pPr>
            <a:lvl6pPr marL="1530020" indent="0" algn="ctr">
              <a:buNone/>
              <a:defRPr sz="1071"/>
            </a:lvl6pPr>
            <a:lvl7pPr marL="1836024" indent="0" algn="ctr">
              <a:buNone/>
              <a:defRPr sz="1071"/>
            </a:lvl7pPr>
            <a:lvl8pPr marL="2142028" indent="0" algn="ctr">
              <a:buNone/>
              <a:defRPr sz="1071"/>
            </a:lvl8pPr>
            <a:lvl9pPr marL="2448032" indent="0" algn="ctr">
              <a:buNone/>
              <a:defRPr sz="1071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0562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55162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379491" y="440855"/>
            <a:ext cx="1319585" cy="7017256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20738" y="440855"/>
            <a:ext cx="3882256" cy="7017256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17514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97645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17550" y="2064352"/>
            <a:ext cx="5278339" cy="3444416"/>
          </a:xfrm>
        </p:spPr>
        <p:txBody>
          <a:bodyPr anchor="b"/>
          <a:lstStyle>
            <a:lvl1pPr>
              <a:defRPr sz="4016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17550" y="5541353"/>
            <a:ext cx="5278339" cy="1811337"/>
          </a:xfrm>
        </p:spPr>
        <p:txBody>
          <a:bodyPr/>
          <a:lstStyle>
            <a:lvl1pPr marL="0" indent="0">
              <a:buNone/>
              <a:defRPr sz="1606">
                <a:solidFill>
                  <a:schemeClr val="tx1"/>
                </a:solidFill>
              </a:defRPr>
            </a:lvl1pPr>
            <a:lvl2pPr marL="306004" indent="0">
              <a:buNone/>
              <a:defRPr sz="1339">
                <a:solidFill>
                  <a:schemeClr val="tx1">
                    <a:tint val="75000"/>
                  </a:schemeClr>
                </a:solidFill>
              </a:defRPr>
            </a:lvl2pPr>
            <a:lvl3pPr marL="612008" indent="0">
              <a:buNone/>
              <a:defRPr sz="1205">
                <a:solidFill>
                  <a:schemeClr val="tx1">
                    <a:tint val="75000"/>
                  </a:schemeClr>
                </a:solidFill>
              </a:defRPr>
            </a:lvl3pPr>
            <a:lvl4pPr marL="91801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4pPr>
            <a:lvl5pPr marL="1224016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5pPr>
            <a:lvl6pPr marL="1530020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6pPr>
            <a:lvl7pPr marL="1836024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7pPr>
            <a:lvl8pPr marL="2142028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8pPr>
            <a:lvl9pPr marL="2448032" indent="0">
              <a:buNone/>
              <a:defRPr sz="107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473094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20737" y="2204273"/>
            <a:ext cx="2600921" cy="52538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098155" y="2204273"/>
            <a:ext cx="2600921" cy="52538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49194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440856"/>
            <a:ext cx="5278339" cy="1600495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1535" y="2029849"/>
            <a:ext cx="2588967" cy="994797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21535" y="3024646"/>
            <a:ext cx="2588967" cy="444879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098155" y="2029849"/>
            <a:ext cx="2601718" cy="994797"/>
          </a:xfrm>
        </p:spPr>
        <p:txBody>
          <a:bodyPr anchor="b"/>
          <a:lstStyle>
            <a:lvl1pPr marL="0" indent="0">
              <a:buNone/>
              <a:defRPr sz="1606" b="1"/>
            </a:lvl1pPr>
            <a:lvl2pPr marL="306004" indent="0">
              <a:buNone/>
              <a:defRPr sz="1339" b="1"/>
            </a:lvl2pPr>
            <a:lvl3pPr marL="612008" indent="0">
              <a:buNone/>
              <a:defRPr sz="1205" b="1"/>
            </a:lvl3pPr>
            <a:lvl4pPr marL="918012" indent="0">
              <a:buNone/>
              <a:defRPr sz="1071" b="1"/>
            </a:lvl4pPr>
            <a:lvl5pPr marL="1224016" indent="0">
              <a:buNone/>
              <a:defRPr sz="1071" b="1"/>
            </a:lvl5pPr>
            <a:lvl6pPr marL="1530020" indent="0">
              <a:buNone/>
              <a:defRPr sz="1071" b="1"/>
            </a:lvl6pPr>
            <a:lvl7pPr marL="1836024" indent="0">
              <a:buNone/>
              <a:defRPr sz="1071" b="1"/>
            </a:lvl7pPr>
            <a:lvl8pPr marL="2142028" indent="0">
              <a:buNone/>
              <a:defRPr sz="1071" b="1"/>
            </a:lvl8pPr>
            <a:lvl9pPr marL="2448032" indent="0">
              <a:buNone/>
              <a:defRPr sz="1071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098155" y="3024646"/>
            <a:ext cx="2601718" cy="4448799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89106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49209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714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52027"/>
            <a:ext cx="1973799" cy="1932093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01718" y="1192226"/>
            <a:ext cx="3098155" cy="5884451"/>
          </a:xfrm>
        </p:spPr>
        <p:txBody>
          <a:bodyPr/>
          <a:lstStyle>
            <a:lvl1pPr>
              <a:defRPr sz="2142"/>
            </a:lvl1pPr>
            <a:lvl2pPr>
              <a:defRPr sz="1874"/>
            </a:lvl2pPr>
            <a:lvl3pPr>
              <a:defRPr sz="1606"/>
            </a:lvl3pPr>
            <a:lvl4pPr>
              <a:defRPr sz="1339"/>
            </a:lvl4pPr>
            <a:lvl5pPr>
              <a:defRPr sz="1339"/>
            </a:lvl5pPr>
            <a:lvl6pPr>
              <a:defRPr sz="1339"/>
            </a:lvl6pPr>
            <a:lvl7pPr>
              <a:defRPr sz="1339"/>
            </a:lvl7pPr>
            <a:lvl8pPr>
              <a:defRPr sz="1339"/>
            </a:lvl8pPr>
            <a:lvl9pPr>
              <a:defRPr sz="1339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84120"/>
            <a:ext cx="1973799" cy="4602140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20123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1534" y="552027"/>
            <a:ext cx="1973799" cy="1932093"/>
          </a:xfrm>
        </p:spPr>
        <p:txBody>
          <a:bodyPr anchor="b"/>
          <a:lstStyle>
            <a:lvl1pPr>
              <a:defRPr sz="2142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01718" y="1192226"/>
            <a:ext cx="3098155" cy="5884451"/>
          </a:xfrm>
        </p:spPr>
        <p:txBody>
          <a:bodyPr anchor="t"/>
          <a:lstStyle>
            <a:lvl1pPr marL="0" indent="0">
              <a:buNone/>
              <a:defRPr sz="2142"/>
            </a:lvl1pPr>
            <a:lvl2pPr marL="306004" indent="0">
              <a:buNone/>
              <a:defRPr sz="1874"/>
            </a:lvl2pPr>
            <a:lvl3pPr marL="612008" indent="0">
              <a:buNone/>
              <a:defRPr sz="1606"/>
            </a:lvl3pPr>
            <a:lvl4pPr marL="918012" indent="0">
              <a:buNone/>
              <a:defRPr sz="1339"/>
            </a:lvl4pPr>
            <a:lvl5pPr marL="1224016" indent="0">
              <a:buNone/>
              <a:defRPr sz="1339"/>
            </a:lvl5pPr>
            <a:lvl6pPr marL="1530020" indent="0">
              <a:buNone/>
              <a:defRPr sz="1339"/>
            </a:lvl6pPr>
            <a:lvl7pPr marL="1836024" indent="0">
              <a:buNone/>
              <a:defRPr sz="1339"/>
            </a:lvl7pPr>
            <a:lvl8pPr marL="2142028" indent="0">
              <a:buNone/>
              <a:defRPr sz="1339"/>
            </a:lvl8pPr>
            <a:lvl9pPr marL="2448032" indent="0">
              <a:buNone/>
              <a:defRPr sz="1339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21534" y="2484120"/>
            <a:ext cx="1973799" cy="4602140"/>
          </a:xfrm>
        </p:spPr>
        <p:txBody>
          <a:bodyPr/>
          <a:lstStyle>
            <a:lvl1pPr marL="0" indent="0">
              <a:buNone/>
              <a:defRPr sz="1071"/>
            </a:lvl1pPr>
            <a:lvl2pPr marL="306004" indent="0">
              <a:buNone/>
              <a:defRPr sz="937"/>
            </a:lvl2pPr>
            <a:lvl3pPr marL="612008" indent="0">
              <a:buNone/>
              <a:defRPr sz="803"/>
            </a:lvl3pPr>
            <a:lvl4pPr marL="918012" indent="0">
              <a:buNone/>
              <a:defRPr sz="669"/>
            </a:lvl4pPr>
            <a:lvl5pPr marL="1224016" indent="0">
              <a:buNone/>
              <a:defRPr sz="669"/>
            </a:lvl5pPr>
            <a:lvl6pPr marL="1530020" indent="0">
              <a:buNone/>
              <a:defRPr sz="669"/>
            </a:lvl6pPr>
            <a:lvl7pPr marL="1836024" indent="0">
              <a:buNone/>
              <a:defRPr sz="669"/>
            </a:lvl7pPr>
            <a:lvl8pPr marL="2142028" indent="0">
              <a:buNone/>
              <a:defRPr sz="669"/>
            </a:lvl8pPr>
            <a:lvl9pPr marL="2448032" indent="0">
              <a:buNone/>
              <a:defRPr sz="669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9131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20737" y="440856"/>
            <a:ext cx="5278339" cy="1600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0737" y="2204273"/>
            <a:ext cx="5278339" cy="52538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20737" y="7674706"/>
            <a:ext cx="1376958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FAC8AF-B650-A947-9E59-63537E4338DB}" type="datetimeFigureOut">
              <a:rPr lang="en-US" smtClean="0"/>
              <a:t>1/25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27188" y="7674706"/>
            <a:ext cx="2065437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322118" y="7674706"/>
            <a:ext cx="1376958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80D768-B7A8-7C4B-8DAC-A7FE470288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06612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12008" rtl="0" eaLnBrk="1" latinLnBrk="0" hangingPunct="1">
        <a:lnSpc>
          <a:spcPct val="90000"/>
        </a:lnSpc>
        <a:spcBef>
          <a:spcPct val="0"/>
        </a:spcBef>
        <a:buNone/>
        <a:defRPr sz="294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53002" indent="-153002" algn="l" defTabSz="612008" rtl="0" eaLnBrk="1" latinLnBrk="0" hangingPunct="1">
        <a:lnSpc>
          <a:spcPct val="90000"/>
        </a:lnSpc>
        <a:spcBef>
          <a:spcPts val="669"/>
        </a:spcBef>
        <a:buFont typeface="Arial" panose="020B0604020202020204" pitchFamily="34" charset="0"/>
        <a:buChar char="•"/>
        <a:defRPr sz="1874" kern="1200">
          <a:solidFill>
            <a:schemeClr val="tx1"/>
          </a:solidFill>
          <a:latin typeface="+mn-lt"/>
          <a:ea typeface="+mn-ea"/>
          <a:cs typeface="+mn-cs"/>
        </a:defRPr>
      </a:lvl1pPr>
      <a:lvl2pPr marL="45900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606" kern="1200">
          <a:solidFill>
            <a:schemeClr val="tx1"/>
          </a:solidFill>
          <a:latin typeface="+mn-lt"/>
          <a:ea typeface="+mn-ea"/>
          <a:cs typeface="+mn-cs"/>
        </a:defRPr>
      </a:lvl2pPr>
      <a:lvl3pPr marL="76501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339" kern="1200">
          <a:solidFill>
            <a:schemeClr val="tx1"/>
          </a:solidFill>
          <a:latin typeface="+mn-lt"/>
          <a:ea typeface="+mn-ea"/>
          <a:cs typeface="+mn-cs"/>
        </a:defRPr>
      </a:lvl3pPr>
      <a:lvl4pPr marL="107101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377018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683022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989026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295030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601034" indent="-153002" algn="l" defTabSz="612008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1pPr>
      <a:lvl2pPr marL="30600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2pPr>
      <a:lvl3pPr marL="61200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3pPr>
      <a:lvl4pPr marL="91801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4pPr>
      <a:lvl5pPr marL="1224016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5pPr>
      <a:lvl6pPr marL="1530020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6pPr>
      <a:lvl7pPr marL="1836024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7pPr>
      <a:lvl8pPr marL="2142028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8pPr>
      <a:lvl9pPr marL="2448032" algn="l" defTabSz="612008" rtl="0" eaLnBrk="1" latinLnBrk="0" hangingPunct="1">
        <a:defRPr sz="120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87D3E2F4-9774-6C4A-8487-8BC7274A2231}"/>
              </a:ext>
            </a:extLst>
          </p:cNvPr>
          <p:cNvGrpSpPr/>
          <p:nvPr/>
        </p:nvGrpSpPr>
        <p:grpSpPr>
          <a:xfrm>
            <a:off x="0" y="1975343"/>
            <a:ext cx="6119813" cy="4329713"/>
            <a:chOff x="0" y="1975343"/>
            <a:chExt cx="6119813" cy="4329713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3BA188F4-5915-154B-BDBA-A79D8FFE8D9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0" y="1975343"/>
              <a:ext cx="6119813" cy="4329713"/>
            </a:xfrm>
            <a:prstGeom prst="rect">
              <a:avLst/>
            </a:prstGeom>
          </p:spPr>
        </p:pic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5B313AB3-39CB-8F46-A4DF-51909F81F42F}"/>
                </a:ext>
              </a:extLst>
            </p:cNvPr>
            <p:cNvSpPr/>
            <p:nvPr/>
          </p:nvSpPr>
          <p:spPr>
            <a:xfrm>
              <a:off x="4371063" y="2725615"/>
              <a:ext cx="873060" cy="134572"/>
            </a:xfrm>
            <a:prstGeom prst="rect">
              <a:avLst/>
            </a:prstGeom>
            <a:solidFill>
              <a:srgbClr val="FF0000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7063CCA1-2839-0840-963F-6E3B7A96C7C9}"/>
                </a:ext>
              </a:extLst>
            </p:cNvPr>
            <p:cNvSpPr/>
            <p:nvPr/>
          </p:nvSpPr>
          <p:spPr>
            <a:xfrm>
              <a:off x="4371063" y="2228449"/>
              <a:ext cx="873060" cy="79931"/>
            </a:xfrm>
            <a:prstGeom prst="rect">
              <a:avLst/>
            </a:prstGeom>
            <a:solidFill>
              <a:srgbClr val="FF0000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A9EB5508-0901-8D48-98BB-67ABEE4EB3F5}"/>
                </a:ext>
              </a:extLst>
            </p:cNvPr>
            <p:cNvSpPr/>
            <p:nvPr/>
          </p:nvSpPr>
          <p:spPr>
            <a:xfrm>
              <a:off x="4371063" y="2925441"/>
              <a:ext cx="873060" cy="73536"/>
            </a:xfrm>
            <a:prstGeom prst="rect">
              <a:avLst/>
            </a:prstGeom>
            <a:solidFill>
              <a:srgbClr val="FF0000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656B5DC2-2AF1-D04B-A15E-8D8D6560B9D8}"/>
                </a:ext>
              </a:extLst>
            </p:cNvPr>
            <p:cNvSpPr/>
            <p:nvPr/>
          </p:nvSpPr>
          <p:spPr>
            <a:xfrm>
              <a:off x="4371063" y="3210136"/>
              <a:ext cx="873060" cy="134572"/>
            </a:xfrm>
            <a:prstGeom prst="rect">
              <a:avLst/>
            </a:prstGeom>
            <a:solidFill>
              <a:srgbClr val="FF0000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DDCB159A-C489-7A4D-B7B5-672ED7A3FE16}"/>
                </a:ext>
              </a:extLst>
            </p:cNvPr>
            <p:cNvSpPr/>
            <p:nvPr/>
          </p:nvSpPr>
          <p:spPr>
            <a:xfrm>
              <a:off x="4371063" y="3555867"/>
              <a:ext cx="873060" cy="88943"/>
            </a:xfrm>
            <a:prstGeom prst="rect">
              <a:avLst/>
            </a:prstGeom>
            <a:solidFill>
              <a:srgbClr val="FF0000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FB803722-A23C-ED4B-AF09-4E194327022C}"/>
                </a:ext>
              </a:extLst>
            </p:cNvPr>
            <p:cNvSpPr/>
            <p:nvPr/>
          </p:nvSpPr>
          <p:spPr>
            <a:xfrm>
              <a:off x="4371063" y="4165955"/>
              <a:ext cx="910716" cy="159859"/>
            </a:xfrm>
            <a:prstGeom prst="rect">
              <a:avLst/>
            </a:prstGeom>
            <a:solidFill>
              <a:srgbClr val="FF0000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9E92E57F-E498-5C4F-8606-56EBCA55E559}"/>
              </a:ext>
            </a:extLst>
          </p:cNvPr>
          <p:cNvSpPr txBox="1"/>
          <p:nvPr/>
        </p:nvSpPr>
        <p:spPr>
          <a:xfrm>
            <a:off x="695325" y="6511264"/>
            <a:ext cx="4729161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Evolution of culm height. Maximum likelihood tree estimated using IQTREE2 v2.1.2 inferred from 333 nuclear genes. Log transformed maximum culm height (cm) in </a:t>
            </a:r>
            <a:r>
              <a:rPr lang="en-GB" sz="1800" b="0" i="1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Urochloa s.l.. </a:t>
            </a:r>
            <a:r>
              <a:rPr lang="en-GB" sz="1800" b="0" i="0" u="none" strike="noStrike" dirty="0">
                <a:solidFill>
                  <a:srgbClr val="000000"/>
                </a:solidFill>
                <a:effectLst/>
                <a:latin typeface="Calibri" panose="020F0502020204030204" pitchFamily="34" charset="0"/>
              </a:rPr>
              <a:t>Ancestral trait estimation along branch lengths. </a:t>
            </a:r>
            <a:endParaRPr lang="en-US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9635F8D-435A-3346-87A8-A1871A1210A4}"/>
              </a:ext>
            </a:extLst>
          </p:cNvPr>
          <p:cNvSpPr txBox="1"/>
          <p:nvPr/>
        </p:nvSpPr>
        <p:spPr>
          <a:xfrm>
            <a:off x="67605" y="1170939"/>
            <a:ext cx="2418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4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21CB169-C4DF-544D-8148-D5034A0286AD}"/>
              </a:ext>
            </a:extLst>
          </p:cNvPr>
          <p:cNvSpPr txBox="1"/>
          <p:nvPr/>
        </p:nvSpPr>
        <p:spPr>
          <a:xfrm>
            <a:off x="67605" y="185876"/>
            <a:ext cx="19745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Masters et al. </a:t>
            </a:r>
            <a:r>
              <a:rPr lang="en-US"/>
              <a:t>2024</a:t>
            </a:r>
            <a:endParaRPr lang="en-US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D11EFC5-8A6B-CE44-8917-89CD4141D138}"/>
              </a:ext>
            </a:extLst>
          </p:cNvPr>
          <p:cNvSpPr txBox="1"/>
          <p:nvPr/>
        </p:nvSpPr>
        <p:spPr>
          <a:xfrm>
            <a:off x="0" y="631436"/>
            <a:ext cx="5556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 Evolutionary origins of the African forage grass </a:t>
            </a:r>
            <a:r>
              <a:rPr lang="en-US" i="1" dirty="0"/>
              <a:t>Urochloa</a:t>
            </a:r>
            <a:r>
              <a:rPr lang="en-US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7507571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28</TotalTime>
  <Words>56</Words>
  <Application>Microsoft Macintosh PowerPoint</Application>
  <PresentationFormat>Custom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zo Masters</dc:creator>
  <cp:lastModifiedBy>Masters, Lizo E.</cp:lastModifiedBy>
  <cp:revision>11</cp:revision>
  <dcterms:created xsi:type="dcterms:W3CDTF">2023-06-01T15:27:18Z</dcterms:created>
  <dcterms:modified xsi:type="dcterms:W3CDTF">2024-01-25T17:28:26Z</dcterms:modified>
</cp:coreProperties>
</file>